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63" r:id="rId2"/>
  </p:sldIdLst>
  <p:sldSz cx="6858000" cy="9906000" type="A4"/>
  <p:notesSz cx="6797675" cy="9926638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enisa Jansova" initials="DJ" lastIdx="9" clrIdx="0">
    <p:extLst>
      <p:ext uri="{19B8F6BF-5375-455C-9EA6-DF929625EA0E}">
        <p15:presenceInfo xmlns:p15="http://schemas.microsoft.com/office/powerpoint/2012/main" userId="S-1-5-21-3131933878-3085778887-74996984-127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6005A"/>
    <a:srgbClr val="000000"/>
    <a:srgbClr val="548235"/>
    <a:srgbClr val="C500E1"/>
    <a:srgbClr val="AFABAB"/>
    <a:srgbClr val="5B9BD5"/>
    <a:srgbClr val="00FE00"/>
    <a:srgbClr val="0000CC"/>
    <a:srgbClr val="0000BA"/>
    <a:srgbClr val="33CC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C7853C-536D-4A76-A0AE-DD22124D55A5}" styleName="Styl s motivem 1 – zvýraznění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Bez stylu, mřížka tabulky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6" autoAdjust="0"/>
    <p:restoredTop sz="96720" autoAdjust="0"/>
  </p:normalViewPr>
  <p:slideViewPr>
    <p:cSldViewPr snapToGrid="0">
      <p:cViewPr varScale="1">
        <p:scale>
          <a:sx n="88" d="100"/>
          <a:sy n="88" d="100"/>
        </p:scale>
        <p:origin x="2844" y="144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25" d="100"/>
        <a:sy n="12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4B2260-476A-4925-923B-1B5A08D90668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866650-2D1A-4EFA-A6FD-9296E3C1D0D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7019624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499"/>
            </a:lvl2pPr>
            <a:lvl3pPr marL="685771" indent="0" algn="ctr">
              <a:buNone/>
              <a:defRPr sz="1351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200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cs-CZ" smtClean="0"/>
              <a:t>Kliknutím lze upravit styl předlohy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001929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2911570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1395084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6366181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71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468265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597809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56170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27796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740352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432460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86" indent="0">
              <a:buNone/>
              <a:defRPr sz="2100"/>
            </a:lvl2pPr>
            <a:lvl3pPr marL="685771" indent="0">
              <a:buNone/>
              <a:defRPr sz="1800"/>
            </a:lvl3pPr>
            <a:lvl4pPr marL="1028657" indent="0">
              <a:buNone/>
              <a:defRPr sz="1499"/>
            </a:lvl4pPr>
            <a:lvl5pPr marL="1371543" indent="0">
              <a:buNone/>
              <a:defRPr sz="1499"/>
            </a:lvl5pPr>
            <a:lvl6pPr marL="1714428" indent="0">
              <a:buNone/>
              <a:defRPr sz="1499"/>
            </a:lvl6pPr>
            <a:lvl7pPr marL="2057314" indent="0">
              <a:buNone/>
              <a:defRPr sz="1499"/>
            </a:lvl7pPr>
            <a:lvl8pPr marL="2400200" indent="0">
              <a:buNone/>
              <a:defRPr sz="1499"/>
            </a:lvl8pPr>
            <a:lvl9pPr marL="2743085" indent="0">
              <a:buNone/>
              <a:defRPr sz="1499"/>
            </a:lvl9pPr>
          </a:lstStyle>
          <a:p>
            <a:r>
              <a:rPr lang="cs-CZ" smtClean="0"/>
              <a:t>Kliknutím na ikonu přidáte obrázek.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990461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C12348-B8D8-4CB5-B64D-197BD6590370}" type="datetimeFigureOut">
              <a:rPr lang="cs-CZ" smtClean="0"/>
              <a:t>05.03.2025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735EC5-F68C-4662-A893-D2DBC6D86C2B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561551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71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9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6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71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0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ulka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27862510"/>
              </p:ext>
            </p:extLst>
          </p:nvPr>
        </p:nvGraphicFramePr>
        <p:xfrm>
          <a:off x="601186" y="290572"/>
          <a:ext cx="5783287" cy="946493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54503">
                  <a:extLst>
                    <a:ext uri="{9D8B030D-6E8A-4147-A177-3AD203B41FA5}">
                      <a16:colId xmlns:a16="http://schemas.microsoft.com/office/drawing/2014/main" val="2245500024"/>
                    </a:ext>
                  </a:extLst>
                </a:gridCol>
                <a:gridCol w="1054503">
                  <a:extLst>
                    <a:ext uri="{9D8B030D-6E8A-4147-A177-3AD203B41FA5}">
                      <a16:colId xmlns:a16="http://schemas.microsoft.com/office/drawing/2014/main" val="3154168428"/>
                    </a:ext>
                  </a:extLst>
                </a:gridCol>
                <a:gridCol w="1054503">
                  <a:extLst>
                    <a:ext uri="{9D8B030D-6E8A-4147-A177-3AD203B41FA5}">
                      <a16:colId xmlns:a16="http://schemas.microsoft.com/office/drawing/2014/main" val="1431584584"/>
                    </a:ext>
                  </a:extLst>
                </a:gridCol>
                <a:gridCol w="286605">
                  <a:extLst>
                    <a:ext uri="{9D8B030D-6E8A-4147-A177-3AD203B41FA5}">
                      <a16:colId xmlns:a16="http://schemas.microsoft.com/office/drawing/2014/main" val="2873097883"/>
                    </a:ext>
                  </a:extLst>
                </a:gridCol>
                <a:gridCol w="127867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054503">
                  <a:extLst>
                    <a:ext uri="{9D8B030D-6E8A-4147-A177-3AD203B41FA5}">
                      <a16:colId xmlns:a16="http://schemas.microsoft.com/office/drawing/2014/main" val="2703209422"/>
                    </a:ext>
                  </a:extLst>
                </a:gridCol>
              </a:tblGrid>
              <a:tr h="298444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u="none" strike="noStrike" noProof="0" dirty="0" smtClean="0">
                          <a:effectLst/>
                        </a:rPr>
                        <a:t>Gene</a:t>
                      </a:r>
                      <a:r>
                        <a:rPr lang="en-GB" sz="1100" b="1" u="none" strike="noStrike" baseline="0" noProof="0" dirty="0" smtClean="0">
                          <a:effectLst/>
                        </a:rPr>
                        <a:t> Symbol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u="none" strike="noStrike" noProof="0" dirty="0" smtClean="0">
                          <a:effectLst/>
                        </a:rPr>
                        <a:t>Forward 5´-3´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u="none" strike="noStrike" noProof="0" dirty="0" smtClean="0">
                          <a:effectLst/>
                        </a:rPr>
                        <a:t>Reverse 5´-3´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685771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1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enBank Accession</a:t>
                      </a:r>
                      <a:r>
                        <a:rPr lang="en-GB" sz="1100" b="1" u="none" strike="noStrike" kern="1200" baseline="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n-GB" sz="1100" b="1" u="none" strike="noStrik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o. </a:t>
                      </a:r>
                      <a:endParaRPr lang="en-GB" sz="1100" b="1" u="none" strike="noStrike" kern="1200" noProof="0" dirty="0" smtClean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u="none" strike="noStrike" noProof="0" dirty="0" smtClean="0">
                          <a:effectLst/>
                        </a:rPr>
                        <a:t>Product Size (bp)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74246982"/>
                  </a:ext>
                </a:extLst>
              </a:tr>
              <a:tr h="298444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i="1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e-bp1</a:t>
                      </a:r>
                      <a:endParaRPr lang="en-GB" sz="1100" i="1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ATCATTGCGTCCTACGGCT </a:t>
                      </a:r>
                      <a:endParaRPr lang="en-GB" sz="1100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TGTCGGAACTCACCTGTGG </a:t>
                      </a:r>
                      <a:endParaRPr lang="en-GB" sz="1100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M_007918.3</a:t>
                      </a:r>
                      <a:endParaRPr lang="en-GB" sz="1100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01</a:t>
                      </a:r>
                      <a:endParaRPr lang="en-GB" sz="1100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8490104"/>
                  </a:ext>
                </a:extLst>
              </a:tr>
              <a:tr h="298444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i="1" u="none" strike="noStrike" kern="1200" noProof="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ire</a:t>
                      </a:r>
                      <a:endParaRPr lang="en-GB" sz="1100" i="1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AGGTGGGGATGGAATGCTAC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AAAACTCTCCCCCAACCTGA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M_009646.2</a:t>
                      </a:r>
                      <a:endParaRPr lang="en-GB" sz="1100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232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80342218"/>
                  </a:ext>
                </a:extLst>
              </a:tr>
              <a:tr h="298444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i="1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dk12 (exon3)</a:t>
                      </a:r>
                      <a:endParaRPr lang="en-GB" sz="1100" i="1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AACAGAGGACTCGCCACTTG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GGAGAATCTGGAGGCGATGG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M_001109626.1</a:t>
                      </a:r>
                      <a:endParaRPr lang="en-GB" sz="1100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82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5167024"/>
                  </a:ext>
                </a:extLst>
              </a:tr>
              <a:tr h="298444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i="1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dk13</a:t>
                      </a:r>
                      <a:endParaRPr lang="en-GB" sz="1100" i="1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GCACCTGGTGAAAAACAGACA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TGTTTGGACTGTTGGGCCTT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M_001081058.2</a:t>
                      </a:r>
                      <a:endParaRPr lang="en-GB" sz="1100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182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49993171"/>
                  </a:ext>
                </a:extLst>
              </a:tr>
              <a:tr h="446155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i="1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not7</a:t>
                      </a:r>
                      <a:endParaRPr lang="en-GB" sz="1100" i="1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effectLst/>
                        </a:rPr>
                        <a:t>GCAGGATCTGACTCACTGCTTA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GTCATGACTGCTTGCTGGCT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/>
                      </a:r>
                      <a:br>
                        <a:rPr lang="en-GB" sz="1100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</a:br>
                      <a:r>
                        <a:rPr lang="en-GB" sz="1100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M_011135.5</a:t>
                      </a:r>
                      <a:br>
                        <a:rPr lang="en-GB" sz="1100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</a:br>
                      <a:endParaRPr lang="en-GB" sz="1100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18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5433785"/>
                  </a:ext>
                </a:extLst>
              </a:tr>
              <a:tr h="298444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i="1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ef2</a:t>
                      </a:r>
                      <a:endParaRPr lang="en-GB" sz="1100" i="1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TTGACGTCAGCGGTCTCTTC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effectLst/>
                        </a:rPr>
                        <a:t>ACATGTTCCGGATGTTGGCT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M_007907.3</a:t>
                      </a:r>
                      <a:endParaRPr lang="en-GB" sz="1100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162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0466877"/>
                  </a:ext>
                </a:extLst>
              </a:tr>
              <a:tr h="446155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i="1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IF4G1</a:t>
                      </a:r>
                      <a:endParaRPr lang="en-GB" sz="1100" i="1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GAGAACATCCAGCCTGGGG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TATGGGGCAATCCTTCTGGC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M_145941.4</a:t>
                      </a:r>
                      <a:endParaRPr lang="en-GB" sz="1100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14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1345585"/>
                  </a:ext>
                </a:extLst>
              </a:tr>
              <a:tr h="446155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i="1" u="none" strike="noStrike" kern="1200" noProof="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igla</a:t>
                      </a:r>
                      <a:endParaRPr lang="en-GB" sz="1100" i="1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AGCGAAGGTCTCAGAGAAACA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CAGCTGGTAGGTTGGGTAGC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M_012013.2</a:t>
                      </a:r>
                      <a:endParaRPr lang="en-GB" sz="1100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11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103927"/>
                  </a:ext>
                </a:extLst>
              </a:tr>
              <a:tr h="446155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i="1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mrp1</a:t>
                      </a: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GTGGTTAGCTAAAGTGAGGAT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CAGGTTTGTTGGGATTAACAGATC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M_008031.4 </a:t>
                      </a:r>
                      <a:endParaRPr lang="en-GB" sz="1100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12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38511121"/>
                  </a:ext>
                </a:extLst>
              </a:tr>
              <a:tr h="298444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i="1" u="none" strike="noStrike" kern="1200" noProof="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apdh</a:t>
                      </a:r>
                      <a:endParaRPr lang="en-GB" sz="1100" i="1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TGGAGAAACCTGCCAAGTATG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GGTCCTCAGTGTAGCCCAAG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M_001289726.2</a:t>
                      </a:r>
                      <a:endParaRPr lang="en-GB" sz="1100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effectLst/>
                        </a:rPr>
                        <a:t>9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5257022"/>
                  </a:ext>
                </a:extLst>
              </a:tr>
              <a:tr h="298444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i="1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df9</a:t>
                      </a:r>
                      <a:endParaRPr lang="en-GB" sz="1100" i="1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AGTGAAGTCAGTCTTCCACAC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effectLst/>
                        </a:rPr>
                        <a:t>TGCCATGACTTGGGAGAACT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M_008110.2</a:t>
                      </a:r>
                      <a:endParaRPr lang="en-GB" sz="1100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12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5210932"/>
                  </a:ext>
                </a:extLst>
              </a:tr>
              <a:tr h="298444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i="1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prt1</a:t>
                      </a:r>
                      <a:endParaRPr lang="en-GB" sz="1100" i="1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TCCTTCTTGGGTATGGAATCCT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GTCTTTACGGATGTCAACGTCAC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M_013556.2 </a:t>
                      </a:r>
                      <a:endParaRPr lang="en-GB" sz="1100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10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6981732"/>
                  </a:ext>
                </a:extLst>
              </a:tr>
              <a:tr h="298444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i="1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ol2a</a:t>
                      </a: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effectLst/>
                        </a:rPr>
                        <a:t>GGACATTCTTTGCCGCTTGG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effectLst/>
                        </a:rPr>
                        <a:t>CACTGTGCTCTGGGGGTTAG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M_001291068.1</a:t>
                      </a:r>
                      <a:endParaRPr lang="en-GB" sz="1100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9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6635998"/>
                  </a:ext>
                </a:extLst>
              </a:tr>
              <a:tr h="298444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i="1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ps26</a:t>
                      </a:r>
                      <a:endParaRPr lang="en-GB" sz="1100" i="1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effectLst/>
                        </a:rPr>
                        <a:t>GAACACCCCCACCACGATTC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effectLst/>
                        </a:rPr>
                        <a:t>CGGCCTCTTTACATGGGCTT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M_013765.2</a:t>
                      </a:r>
                      <a:endParaRPr lang="en-GB" sz="1100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7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5592230"/>
                  </a:ext>
                </a:extLst>
              </a:tr>
              <a:tr h="150733">
                <a:tc gridSpan="6">
                  <a:txBody>
                    <a:bodyPr/>
                    <a:lstStyle/>
                    <a:p>
                      <a:pPr algn="ctr" rtl="0" fontAlgn="ctr"/>
                      <a:r>
                        <a:rPr lang="en-GB" sz="1100" b="1" u="none" strike="noStrike" noProof="0" dirty="0" smtClean="0">
                          <a:effectLst/>
                        </a:rPr>
                        <a:t>Antibodies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00744765"/>
                  </a:ext>
                </a:extLst>
              </a:tr>
              <a:tr h="15073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1" u="none" strike="noStrike" noProof="0" dirty="0" smtClean="0">
                          <a:effectLst/>
                        </a:rPr>
                        <a:t>Name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GB" sz="1100" b="1" u="none" strike="noStrike" noProof="0" dirty="0" smtClean="0">
                          <a:effectLst/>
                        </a:rPr>
                        <a:t>Company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cs-CZ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100" b="1" u="none" strike="noStrike" noProof="0" dirty="0" smtClean="0">
                          <a:effectLst/>
                        </a:rPr>
                        <a:t>Cat.</a:t>
                      </a:r>
                      <a:r>
                        <a:rPr lang="en-GB" sz="1100" b="1" u="none" strike="noStrike" baseline="0" noProof="0" dirty="0" smtClean="0">
                          <a:effectLst/>
                        </a:rPr>
                        <a:t> </a:t>
                      </a:r>
                      <a:r>
                        <a:rPr lang="en-GB" sz="1100" b="1" u="none" strike="noStrik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o.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15213824"/>
                  </a:ext>
                </a:extLst>
              </a:tr>
              <a:tr h="15073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effectLst/>
                        </a:rPr>
                        <a:t>4E-BP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Cell Sign. Tech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cs-CZ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CS9644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24650941"/>
                  </a:ext>
                </a:extLst>
              </a:tr>
              <a:tr h="15073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effectLst/>
                        </a:rPr>
                        <a:t>CCNK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err="1" smtClean="0">
                          <a:solidFill>
                            <a:schemeClr val="tx1"/>
                          </a:solidFill>
                          <a:effectLst/>
                        </a:rPr>
                        <a:t>Abnova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cs-CZ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H8812-M01A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1548952"/>
                  </a:ext>
                </a:extLst>
              </a:tr>
              <a:tr h="15073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effectLst/>
                        </a:rPr>
                        <a:t>CDK12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Millipore Merck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cs-CZ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ABE1861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36526380"/>
                  </a:ext>
                </a:extLst>
              </a:tr>
              <a:tr h="15073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effectLst/>
                        </a:rPr>
                        <a:t>CDK1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Sigma Aldrich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cs-CZ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HPA05924</a:t>
                      </a:r>
                      <a:r>
                        <a:rPr lang="cs-CZ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36823812"/>
                  </a:ext>
                </a:extLst>
              </a:tr>
              <a:tr h="15073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effectLst/>
                        </a:rPr>
                        <a:t>CNOT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Sigma Aldrich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cs-CZ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WH0029883M1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52069763"/>
                  </a:ext>
                </a:extLst>
              </a:tr>
              <a:tr h="15073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effectLst/>
                        </a:rPr>
                        <a:t>EEF2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Cell Sign. Tech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cs-CZ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2332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9059776"/>
                  </a:ext>
                </a:extLst>
              </a:tr>
              <a:tr h="15073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effectLst/>
                        </a:rPr>
                        <a:t>EIF4G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Cell Sign. Tech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cs-CZ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8701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66821152"/>
                  </a:ext>
                </a:extLst>
              </a:tr>
              <a:tr h="15073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effectLst/>
                        </a:rPr>
                        <a:t>GAPDH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Cell Sign. Tech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cs-CZ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97166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19750088"/>
                  </a:ext>
                </a:extLst>
              </a:tr>
              <a:tr h="15073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effectLst/>
                        </a:rPr>
                        <a:t>GDF9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Invitrogen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cs-CZ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PA5-96198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67828067"/>
                  </a:ext>
                </a:extLst>
              </a:tr>
              <a:tr h="15073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effectLst/>
                        </a:rPr>
                        <a:t>POLII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Cell Sign. Tech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cs-CZ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2629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92825207"/>
                  </a:ext>
                </a:extLst>
              </a:tr>
              <a:tr h="15073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effectLst/>
                        </a:rPr>
                        <a:t>POLII (S2)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Millipore Merck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cs-CZ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MABE953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4218745"/>
                  </a:ext>
                </a:extLst>
              </a:tr>
              <a:tr h="15073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effectLst/>
                        </a:rPr>
                        <a:t>RPS2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Invitrogen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cs-CZ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PA5-90218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20492480"/>
                  </a:ext>
                </a:extLst>
              </a:tr>
              <a:tr h="14961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c-TUB</a:t>
                      </a:r>
                      <a:endParaRPr lang="en-GB" sz="1100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Cell Sign. Tech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cs-CZ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5335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15348010"/>
                  </a:ext>
                </a:extLst>
              </a:tr>
              <a:tr h="150733">
                <a:tc gridSpan="6">
                  <a:txBody>
                    <a:bodyPr/>
                    <a:lstStyle/>
                    <a:p>
                      <a:pPr algn="ctr" rtl="0" fontAlgn="b"/>
                      <a:r>
                        <a:rPr lang="en-GB" sz="1100" b="1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PAT Assay </a:t>
                      </a:r>
                      <a:endParaRPr lang="en-GB" sz="1100" b="1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36244410"/>
                  </a:ext>
                </a:extLst>
              </a:tr>
              <a:tr h="15073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u="none" strike="noStrike" noProof="0" dirty="0" smtClean="0">
                          <a:effectLst/>
                        </a:rPr>
                        <a:t>Name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5">
                  <a:txBody>
                    <a:bodyPr/>
                    <a:lstStyle/>
                    <a:p>
                      <a:pPr algn="ctr" rtl="0" fontAlgn="ctr"/>
                      <a:r>
                        <a:rPr lang="en-GB" sz="1100" b="1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Sequence</a:t>
                      </a:r>
                      <a:endParaRPr lang="en-GB" sz="1100" b="1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47889175"/>
                  </a:ext>
                </a:extLst>
              </a:tr>
              <a:tr h="15073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PAT 4E-BP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5"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CCTCATACCAGGCAGACACT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84793957"/>
                  </a:ext>
                </a:extLst>
              </a:tr>
              <a:tr h="15073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PAT CNOT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5"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solidFill>
                            <a:schemeClr val="tx1"/>
                          </a:solidFill>
                          <a:effectLst/>
                        </a:rPr>
                        <a:t>GACCAGAGCATGTGTTGGAAGATTTTG</a:t>
                      </a:r>
                      <a:endParaRPr lang="en-GB" sz="1100" b="0" i="0" u="none" strike="noStrike" noProof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56082355"/>
                  </a:ext>
                </a:extLst>
              </a:tr>
              <a:tr h="15073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Anchor primer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5"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noProof="0" dirty="0" smtClean="0">
                          <a:effectLst/>
                        </a:rPr>
                        <a:t>GCGAGCTCCGCTTTTTTTTTTTT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52123876"/>
                  </a:ext>
                </a:extLst>
              </a:tr>
              <a:tr h="162519">
                <a:tc gridSpan="6">
                  <a:txBody>
                    <a:bodyPr/>
                    <a:lstStyle/>
                    <a:p>
                      <a:pPr algn="ctr" rtl="0" fontAlgn="b"/>
                      <a:r>
                        <a:rPr lang="en-GB" sz="1100" b="1" u="none" strike="noStrike" noProof="0" dirty="0" smtClean="0">
                          <a:effectLst/>
                        </a:rPr>
                        <a:t>RNA FISH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39229457"/>
                  </a:ext>
                </a:extLst>
              </a:tr>
              <a:tr h="16251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u="none" strike="noStrike" noProof="0" dirty="0" smtClean="0">
                          <a:effectLst/>
                        </a:rPr>
                        <a:t>Name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5">
                  <a:txBody>
                    <a:bodyPr/>
                    <a:lstStyle/>
                    <a:p>
                      <a:pPr algn="ctr" rtl="0" fontAlgn="b"/>
                      <a:r>
                        <a:rPr lang="en-GB" sz="1100" b="1" u="none" strike="noStrike" noProof="0" dirty="0" smtClean="0">
                          <a:effectLst/>
                        </a:rPr>
                        <a:t>Sequence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70677281"/>
                  </a:ext>
                </a:extLst>
              </a:tr>
              <a:tr h="15073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u="none" strike="noStrike" kern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oly(A) probe</a:t>
                      </a:r>
                      <a:endParaRPr lang="en-GB" sz="1100" u="none" strike="noStrike" kern="1200" noProof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5">
                  <a:txBody>
                    <a:bodyPr/>
                    <a:lstStyle/>
                    <a:p>
                      <a:pPr algn="ctr" rtl="0" fontAlgn="ctr"/>
                      <a:r>
                        <a:rPr lang="en-GB" sz="1100" u="none" strike="noStrike" noProof="0" dirty="0" smtClean="0">
                          <a:effectLst/>
                        </a:rPr>
                        <a:t>NTTTTTTTTTTTTTTTTTTTT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429" marR="3429" marT="3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55469328"/>
                  </a:ext>
                </a:extLst>
              </a:tr>
            </a:tbl>
          </a:graphicData>
        </a:graphic>
      </p:graphicFrame>
      <p:sp>
        <p:nvSpPr>
          <p:cNvPr id="3" name="TextovéPole 2"/>
          <p:cNvSpPr txBox="1"/>
          <p:nvPr/>
        </p:nvSpPr>
        <p:spPr>
          <a:xfrm>
            <a:off x="0" y="-17205"/>
            <a:ext cx="63162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Supplementary </a:t>
            </a:r>
            <a:r>
              <a:rPr lang="cs-CZ" sz="1400" b="1" dirty="0" smtClean="0"/>
              <a:t>Table </a:t>
            </a:r>
            <a:r>
              <a:rPr lang="en-US" sz="1400" b="1" smtClean="0"/>
              <a:t>2: </a:t>
            </a:r>
            <a:r>
              <a:rPr lang="en-US" sz="1400" dirty="0" smtClean="0"/>
              <a:t>List of primers, antibodies and sequences used in the study.</a:t>
            </a:r>
            <a:endParaRPr lang="cs-CZ" sz="1400" dirty="0"/>
          </a:p>
        </p:txBody>
      </p:sp>
    </p:spTree>
    <p:extLst>
      <p:ext uri="{BB962C8B-B14F-4D97-AF65-F5344CB8AC3E}">
        <p14:creationId xmlns:p14="http://schemas.microsoft.com/office/powerpoint/2010/main" val="2918529176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Motiv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iv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iv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Motiv Office">
  <a:themeElements>
    <a:clrScheme name="Kancelář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celář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5603</TotalTime>
  <Words>202</Words>
  <Application>Microsoft Office PowerPoint</Application>
  <PresentationFormat>A4 (210 × 297 mm)</PresentationFormat>
  <Paragraphs>133</Paragraphs>
  <Slides>1</Slides>
  <Notes>0</Notes>
  <HiddenSlides>0</HiddenSlides>
  <MMClips>0</MMClips>
  <ScaleCrop>false</ScaleCrop>
  <HeadingPairs>
    <vt:vector size="6" baseType="variant">
      <vt:variant>
        <vt:lpstr>Použitá písma</vt:lpstr>
      </vt:variant>
      <vt:variant>
        <vt:i4>3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iv Office</vt:lpstr>
      <vt:lpstr>Prezentace aplikac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DK12</dc:title>
  <dc:creator>Denisa Jansova</dc:creator>
  <cp:lastModifiedBy>Andrej Susor</cp:lastModifiedBy>
  <cp:revision>3406</cp:revision>
  <cp:lastPrinted>2025-01-20T07:33:19Z</cp:lastPrinted>
  <dcterms:created xsi:type="dcterms:W3CDTF">2019-10-07T13:18:56Z</dcterms:created>
  <dcterms:modified xsi:type="dcterms:W3CDTF">2025-03-05T09:43:14Z</dcterms:modified>
</cp:coreProperties>
</file>